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 snapToObjects="1" showGuides="1">
      <p:cViewPr varScale="1">
        <p:scale>
          <a:sx n="104" d="100"/>
          <a:sy n="104" d="100"/>
        </p:scale>
        <p:origin x="232" y="5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42B6A8A4-A1AD-8045-BF33-46FDC5394B4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id="{854E87E8-017F-D24E-B9A4-5F218CA59B0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E50662FA-B6F2-9A4F-99A9-4FFBF45B5E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8CB7B-B81C-DD48-8525-3D3D155A9528}" type="datetimeFigureOut">
              <a:rPr kumimoji="1" lang="zh-TW" altLang="en-US" smtClean="0"/>
              <a:t>2022/4/7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622C4FD3-EBAE-C74D-A3F6-27917B89A3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C1BD317A-C2E9-A44B-A0FD-53A30D304E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655F8-E38C-AC49-A2B0-760950687D7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7676321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ECC3EF8D-2C59-8345-BAF5-05BF7B4B67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44D1FC73-6D46-3841-8FF6-56F11E068D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51C7AB25-BAE8-D048-9020-A230FE1534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8CB7B-B81C-DD48-8525-3D3D155A9528}" type="datetimeFigureOut">
              <a:rPr kumimoji="1" lang="zh-TW" altLang="en-US" smtClean="0"/>
              <a:t>2022/4/7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2519ABE8-B729-2F49-968D-0E1A67EE41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0AA37771-2676-A64B-96B2-6E83B0BE3F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655F8-E38C-AC49-A2B0-760950687D7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4017619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id="{637A3D79-9BB8-7B46-B987-E2976579D71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AEDAE4DA-B813-C44D-8F9D-21E2A5901EA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E8EC67F8-7137-854C-ADC5-245E0E6DD7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8CB7B-B81C-DD48-8525-3D3D155A9528}" type="datetimeFigureOut">
              <a:rPr kumimoji="1" lang="zh-TW" altLang="en-US" smtClean="0"/>
              <a:t>2022/4/7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AD3B69C7-B9C0-9348-B3E7-7A5D7579E6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3ECF1897-28B6-A646-8AA7-DD4A81A4C2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655F8-E38C-AC49-A2B0-760950687D7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602371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F51F91D3-0AA2-F943-A27B-9576DB4D6A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E552BD6D-0EEC-884B-A974-935B7F7D9EC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E837F53A-F19D-9A4C-AFD1-48928E825A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8CB7B-B81C-DD48-8525-3D3D155A9528}" type="datetimeFigureOut">
              <a:rPr kumimoji="1" lang="zh-TW" altLang="en-US" smtClean="0"/>
              <a:t>2022/4/7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9AEA4EF3-1F70-5C42-9EDC-C2CBE80259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D229F719-6ABB-FB40-8A93-9050E492AF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655F8-E38C-AC49-A2B0-760950687D7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0184416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E2530EF6-2F39-A84E-A5CF-3CE38E7905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AC63C620-297B-784C-BA0E-8A2600D70D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F4433071-3503-9F48-993F-9FD4AC7570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8CB7B-B81C-DD48-8525-3D3D155A9528}" type="datetimeFigureOut">
              <a:rPr kumimoji="1" lang="zh-TW" altLang="en-US" smtClean="0"/>
              <a:t>2022/4/7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B0E04555-AFC6-F540-8014-3F7CDFC48A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BF7C6731-6F6D-AD40-9DAE-7D559D67BE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655F8-E38C-AC49-A2B0-760950687D7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1972058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0C9D5F3D-D810-E44C-A4F5-C6CED085AD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44198029-D780-4D42-BAA9-FA0682E4B30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9E2B78B1-BC83-4042-8D08-A9AC8CDD25B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D50A2E5C-54D4-1545-A2A2-51D42A064E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8CB7B-B81C-DD48-8525-3D3D155A9528}" type="datetimeFigureOut">
              <a:rPr kumimoji="1" lang="zh-TW" altLang="en-US" smtClean="0"/>
              <a:t>2022/4/7</a:t>
            </a:fld>
            <a:endParaRPr kumimoji="1"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3FA44A8B-CF9C-E54F-81CE-E02219BD3E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C68D50C5-0B0D-9940-BB13-7FF21D49EB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655F8-E38C-AC49-A2B0-760950687D7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3390770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8F128B5C-9358-A24B-B01D-484E139A019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315CA27B-F9B7-DD4A-A46F-1F77547D77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8449341B-27C1-0F42-8323-2E6FF47F0C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id="{C2F35F82-C7F8-154C-989C-561803C571A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id="{016E2727-F512-6549-9312-0BD65B322D5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id="{B9F0C761-63C6-BD4E-B28D-19B0F4059F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8CB7B-B81C-DD48-8525-3D3D155A9528}" type="datetimeFigureOut">
              <a:rPr kumimoji="1" lang="zh-TW" altLang="en-US" smtClean="0"/>
              <a:t>2022/4/7</a:t>
            </a:fld>
            <a:endParaRPr kumimoji="1" lang="zh-TW" altLang="en-US"/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id="{C513E6BF-3333-B845-931E-50D0AB742E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id="{6932CD18-D573-C845-9F03-119057E5CD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655F8-E38C-AC49-A2B0-760950687D7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9404065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184A67C8-8E8C-A146-947D-41EFD8FCE0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id="{898BF0B5-9003-584F-B38B-5D725EAE2F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8CB7B-B81C-DD48-8525-3D3D155A9528}" type="datetimeFigureOut">
              <a:rPr kumimoji="1" lang="zh-TW" altLang="en-US" smtClean="0"/>
              <a:t>2022/4/7</a:t>
            </a:fld>
            <a:endParaRPr kumimoji="1" lang="zh-TW" altLang="en-US"/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id="{881CB348-91A8-7840-8722-9D677A6C1F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id="{4E555584-39CA-E24B-BE39-A0DDE253BC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655F8-E38C-AC49-A2B0-760950687D7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22198815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id="{2A1E9810-CA94-0F4C-8E48-2C50A8E9A8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8CB7B-B81C-DD48-8525-3D3D155A9528}" type="datetimeFigureOut">
              <a:rPr kumimoji="1" lang="zh-TW" altLang="en-US" smtClean="0"/>
              <a:t>2022/4/7</a:t>
            </a:fld>
            <a:endParaRPr kumimoji="1" lang="zh-TW" altLang="en-US"/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id="{C28A98C0-4EA8-8443-AE8A-2888D4EB36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3AA3C891-1221-594C-9E14-9DC95ADC2D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655F8-E38C-AC49-A2B0-760950687D7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834727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F42F0255-64C5-F44F-9928-6008E8D3A2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F33CE691-6C70-054F-860B-2233D5290C9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63FF0C77-4975-4E44-856D-63F313C4EB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F23F229D-89FD-1546-B7AA-6627FA35BE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8CB7B-B81C-DD48-8525-3D3D155A9528}" type="datetimeFigureOut">
              <a:rPr kumimoji="1" lang="zh-TW" altLang="en-US" smtClean="0"/>
              <a:t>2022/4/7</a:t>
            </a:fld>
            <a:endParaRPr kumimoji="1"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5959A5C0-1F37-B541-B3A7-5779855519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8D2971BF-136F-0C49-A51B-CC51FBFE83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655F8-E38C-AC49-A2B0-760950687D7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5766657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9244BD76-6540-824B-AAA0-BC5FDC9EB0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id="{0C7DC171-302D-0442-B135-35EAEF0E8EB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C1C18750-33D0-0742-A6AE-1FC25DDDC3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993C8111-5FD3-9F42-A022-EA18F5E664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78CB7B-B81C-DD48-8525-3D3D155A9528}" type="datetimeFigureOut">
              <a:rPr kumimoji="1" lang="zh-TW" altLang="en-US" smtClean="0"/>
              <a:t>2022/4/7</a:t>
            </a:fld>
            <a:endParaRPr kumimoji="1"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CD063149-63BD-0843-BA99-E7502A4844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A7246902-7844-B046-B272-CD6D7B6CFC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0655F8-E38C-AC49-A2B0-760950687D7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18485856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id="{BB24140E-CCC6-8146-8DCE-38F13379E2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772E98B7-1990-D14F-9826-EF361363B2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TW" altLang="en-US"/>
              <a:t>按一下以編輯母片文字樣式</a:t>
            </a:r>
          </a:p>
          <a:p>
            <a:pPr lvl="1"/>
            <a:r>
              <a:rPr kumimoji="1" lang="zh-TW" altLang="en-US"/>
              <a:t>第二層</a:t>
            </a:r>
          </a:p>
          <a:p>
            <a:pPr lvl="2"/>
            <a:r>
              <a:rPr kumimoji="1" lang="zh-TW" altLang="en-US"/>
              <a:t>第三層</a:t>
            </a:r>
          </a:p>
          <a:p>
            <a:pPr lvl="3"/>
            <a:r>
              <a:rPr kumimoji="1" lang="zh-TW" altLang="en-US"/>
              <a:t>第四層</a:t>
            </a:r>
          </a:p>
          <a:p>
            <a:pPr lvl="4"/>
            <a:r>
              <a:rPr kumimoji="1"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93EFC51B-3E4E-BD4F-8178-16943FC4EB7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78CB7B-B81C-DD48-8525-3D3D155A9528}" type="datetimeFigureOut">
              <a:rPr kumimoji="1" lang="zh-TW" altLang="en-US" smtClean="0"/>
              <a:t>2022/4/7</a:t>
            </a:fld>
            <a:endParaRPr kumimoji="1"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EC99027F-E7D9-5845-B7AF-CB17DA76935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F33AC56A-127A-E945-B5F5-612DE5E3AF1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0655F8-E38C-AC49-A2B0-760950687D79}" type="slidenum">
              <a:rPr kumimoji="1" lang="zh-TW" altLang="en-US" smtClean="0"/>
              <a:t>‹#›</a:t>
            </a:fld>
            <a:endParaRPr kumimoji="1" lang="zh-TW" altLang="en-US"/>
          </a:p>
        </p:txBody>
      </p:sp>
    </p:spTree>
    <p:extLst>
      <p:ext uri="{BB962C8B-B14F-4D97-AF65-F5344CB8AC3E}">
        <p14:creationId xmlns:p14="http://schemas.microsoft.com/office/powerpoint/2010/main" val="31946341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圖片 4">
            <a:extLst>
              <a:ext uri="{FF2B5EF4-FFF2-40B4-BE49-F238E27FC236}">
                <a16:creationId xmlns:a16="http://schemas.microsoft.com/office/drawing/2014/main" id="{FD1000B0-D9DD-5743-A753-69244B8E36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44057" y="993333"/>
            <a:ext cx="6147943" cy="4955059"/>
          </a:xfrm>
          <a:prstGeom prst="rect">
            <a:avLst/>
          </a:prstGeom>
        </p:spPr>
      </p:pic>
      <p:pic>
        <p:nvPicPr>
          <p:cNvPr id="7" name="圖片 6" descr="一張含有 文字 的圖片&#10;&#10;自動產生的描述">
            <a:extLst>
              <a:ext uri="{FF2B5EF4-FFF2-40B4-BE49-F238E27FC236}">
                <a16:creationId xmlns:a16="http://schemas.microsoft.com/office/drawing/2014/main" id="{DEE04327-AA9F-3645-B4C1-E6C4FDE6FC1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993334"/>
            <a:ext cx="6147943" cy="4955059"/>
          </a:xfrm>
          <a:prstGeom prst="rect">
            <a:avLst/>
          </a:prstGeom>
        </p:spPr>
      </p:pic>
      <p:sp>
        <p:nvSpPr>
          <p:cNvPr id="8" name="文字方塊 7">
            <a:extLst>
              <a:ext uri="{FF2B5EF4-FFF2-40B4-BE49-F238E27FC236}">
                <a16:creationId xmlns:a16="http://schemas.microsoft.com/office/drawing/2014/main" id="{82584C7A-0319-B545-908C-8DA15B873653}"/>
              </a:ext>
            </a:extLst>
          </p:cNvPr>
          <p:cNvSpPr txBox="1"/>
          <p:nvPr/>
        </p:nvSpPr>
        <p:spPr>
          <a:xfrm>
            <a:off x="7019896" y="5948392"/>
            <a:ext cx="4827796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b="1" dirty="0"/>
              <a:t>Lane 1-3: BM extract from 3 Ctrl animals</a:t>
            </a:r>
          </a:p>
          <a:p>
            <a:r>
              <a:rPr kumimoji="1" lang="en-US" altLang="zh-TW" b="1" dirty="0"/>
              <a:t>Lane 4-6: BM extract from 3 Spltc1 ECKO animals</a:t>
            </a:r>
            <a:endParaRPr kumimoji="1" lang="zh-TW" altLang="en-US" b="1" dirty="0"/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945B3797-5CE7-D943-83C6-3B598EE161E5}"/>
              </a:ext>
            </a:extLst>
          </p:cNvPr>
          <p:cNvSpPr txBox="1"/>
          <p:nvPr/>
        </p:nvSpPr>
        <p:spPr>
          <a:xfrm>
            <a:off x="2720342" y="3101530"/>
            <a:ext cx="15798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/>
              <a:t>1  2  3  4  5  6</a:t>
            </a:r>
            <a:endParaRPr kumimoji="1" lang="zh-TW" altLang="en-US" dirty="0"/>
          </a:p>
        </p:txBody>
      </p:sp>
      <p:sp>
        <p:nvSpPr>
          <p:cNvPr id="10" name="文字方塊 9">
            <a:extLst>
              <a:ext uri="{FF2B5EF4-FFF2-40B4-BE49-F238E27FC236}">
                <a16:creationId xmlns:a16="http://schemas.microsoft.com/office/drawing/2014/main" id="{02364E4E-1C8E-CF43-91EB-65491C1A84B7}"/>
              </a:ext>
            </a:extLst>
          </p:cNvPr>
          <p:cNvSpPr txBox="1"/>
          <p:nvPr/>
        </p:nvSpPr>
        <p:spPr>
          <a:xfrm>
            <a:off x="1915298" y="2323069"/>
            <a:ext cx="6559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400" b="1" dirty="0">
                <a:solidFill>
                  <a:schemeClr val="bg1"/>
                </a:solidFill>
              </a:rPr>
              <a:t>55kDa</a:t>
            </a:r>
            <a:endParaRPr kumimoji="1" lang="zh-TW" altLang="en-US" sz="1400" b="1" dirty="0">
              <a:solidFill>
                <a:schemeClr val="bg1"/>
              </a:solidFill>
            </a:endParaRPr>
          </a:p>
        </p:txBody>
      </p:sp>
      <p:sp>
        <p:nvSpPr>
          <p:cNvPr id="11" name="文字方塊 10">
            <a:extLst>
              <a:ext uri="{FF2B5EF4-FFF2-40B4-BE49-F238E27FC236}">
                <a16:creationId xmlns:a16="http://schemas.microsoft.com/office/drawing/2014/main" id="{4E9D4264-6A1D-8548-B6EF-B1F62DC48DA0}"/>
              </a:ext>
            </a:extLst>
          </p:cNvPr>
          <p:cNvSpPr txBox="1"/>
          <p:nvPr/>
        </p:nvSpPr>
        <p:spPr>
          <a:xfrm>
            <a:off x="1882348" y="2611396"/>
            <a:ext cx="6559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400" b="1" dirty="0">
                <a:solidFill>
                  <a:schemeClr val="bg1"/>
                </a:solidFill>
              </a:rPr>
              <a:t>35kDa</a:t>
            </a:r>
            <a:endParaRPr kumimoji="1" lang="zh-TW" altLang="en-US" sz="1400" b="1" dirty="0">
              <a:solidFill>
                <a:schemeClr val="bg1"/>
              </a:solidFill>
            </a:endParaRPr>
          </a:p>
        </p:txBody>
      </p:sp>
      <p:sp>
        <p:nvSpPr>
          <p:cNvPr id="12" name="文字方塊 11">
            <a:extLst>
              <a:ext uri="{FF2B5EF4-FFF2-40B4-BE49-F238E27FC236}">
                <a16:creationId xmlns:a16="http://schemas.microsoft.com/office/drawing/2014/main" id="{017E9AE4-E967-C84D-8EC8-A04EE47D9773}"/>
              </a:ext>
            </a:extLst>
          </p:cNvPr>
          <p:cNvSpPr txBox="1"/>
          <p:nvPr/>
        </p:nvSpPr>
        <p:spPr>
          <a:xfrm>
            <a:off x="1837038" y="2875008"/>
            <a:ext cx="6559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400" b="1" dirty="0">
                <a:solidFill>
                  <a:schemeClr val="bg1"/>
                </a:solidFill>
              </a:rPr>
              <a:t>25kDa</a:t>
            </a:r>
            <a:endParaRPr kumimoji="1" lang="zh-TW" altLang="en-US" sz="1400" b="1" dirty="0">
              <a:solidFill>
                <a:schemeClr val="bg1"/>
              </a:solidFill>
            </a:endParaRPr>
          </a:p>
        </p:txBody>
      </p:sp>
      <p:sp>
        <p:nvSpPr>
          <p:cNvPr id="13" name="文字方塊 12">
            <a:extLst>
              <a:ext uri="{FF2B5EF4-FFF2-40B4-BE49-F238E27FC236}">
                <a16:creationId xmlns:a16="http://schemas.microsoft.com/office/drawing/2014/main" id="{368A4E7A-0EC9-3045-9EA0-139F0899769B}"/>
              </a:ext>
            </a:extLst>
          </p:cNvPr>
          <p:cNvSpPr txBox="1"/>
          <p:nvPr/>
        </p:nvSpPr>
        <p:spPr>
          <a:xfrm>
            <a:off x="1841155" y="3447540"/>
            <a:ext cx="6559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400" b="1" dirty="0">
                <a:solidFill>
                  <a:schemeClr val="bg1"/>
                </a:solidFill>
              </a:rPr>
              <a:t>15kDa</a:t>
            </a:r>
            <a:endParaRPr kumimoji="1" lang="zh-TW" altLang="en-US" sz="1400" b="1" dirty="0">
              <a:solidFill>
                <a:schemeClr val="bg1"/>
              </a:solidFill>
            </a:endParaRPr>
          </a:p>
        </p:txBody>
      </p:sp>
      <p:sp>
        <p:nvSpPr>
          <p:cNvPr id="14" name="文字方塊 13">
            <a:extLst>
              <a:ext uri="{FF2B5EF4-FFF2-40B4-BE49-F238E27FC236}">
                <a16:creationId xmlns:a16="http://schemas.microsoft.com/office/drawing/2014/main" id="{55313366-106C-A349-A4CB-05E38597E5A2}"/>
              </a:ext>
            </a:extLst>
          </p:cNvPr>
          <p:cNvSpPr txBox="1"/>
          <p:nvPr/>
        </p:nvSpPr>
        <p:spPr>
          <a:xfrm>
            <a:off x="7687444" y="2864140"/>
            <a:ext cx="6559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400" b="1" dirty="0"/>
              <a:t>55kDa</a:t>
            </a:r>
            <a:endParaRPr kumimoji="1" lang="zh-TW" altLang="en-US" sz="1400" b="1" dirty="0"/>
          </a:p>
        </p:txBody>
      </p:sp>
      <p:sp>
        <p:nvSpPr>
          <p:cNvPr id="15" name="文字方塊 14">
            <a:extLst>
              <a:ext uri="{FF2B5EF4-FFF2-40B4-BE49-F238E27FC236}">
                <a16:creationId xmlns:a16="http://schemas.microsoft.com/office/drawing/2014/main" id="{E7A79E8A-4743-764B-B0CE-F5A716C90A1C}"/>
              </a:ext>
            </a:extLst>
          </p:cNvPr>
          <p:cNvSpPr txBox="1"/>
          <p:nvPr/>
        </p:nvSpPr>
        <p:spPr>
          <a:xfrm>
            <a:off x="7654494" y="3152467"/>
            <a:ext cx="6559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400" b="1" dirty="0"/>
              <a:t>35kDa</a:t>
            </a:r>
            <a:endParaRPr kumimoji="1" lang="zh-TW" altLang="en-US" sz="1400" b="1" dirty="0"/>
          </a:p>
        </p:txBody>
      </p:sp>
      <p:sp>
        <p:nvSpPr>
          <p:cNvPr id="16" name="文字方塊 15">
            <a:extLst>
              <a:ext uri="{FF2B5EF4-FFF2-40B4-BE49-F238E27FC236}">
                <a16:creationId xmlns:a16="http://schemas.microsoft.com/office/drawing/2014/main" id="{1D5C88E9-2B31-AC47-B8E9-912D3E97669F}"/>
              </a:ext>
            </a:extLst>
          </p:cNvPr>
          <p:cNvSpPr txBox="1"/>
          <p:nvPr/>
        </p:nvSpPr>
        <p:spPr>
          <a:xfrm>
            <a:off x="7609184" y="3416079"/>
            <a:ext cx="6559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400" b="1" dirty="0"/>
              <a:t>25kDa</a:t>
            </a:r>
            <a:endParaRPr kumimoji="1" lang="zh-TW" altLang="en-US" sz="1400" b="1" dirty="0"/>
          </a:p>
        </p:txBody>
      </p:sp>
      <p:sp>
        <p:nvSpPr>
          <p:cNvPr id="17" name="文字方塊 16">
            <a:extLst>
              <a:ext uri="{FF2B5EF4-FFF2-40B4-BE49-F238E27FC236}">
                <a16:creationId xmlns:a16="http://schemas.microsoft.com/office/drawing/2014/main" id="{0DE45B10-A860-C14B-8C99-BAE6DCD68BFA}"/>
              </a:ext>
            </a:extLst>
          </p:cNvPr>
          <p:cNvSpPr txBox="1"/>
          <p:nvPr/>
        </p:nvSpPr>
        <p:spPr>
          <a:xfrm>
            <a:off x="7613301" y="3988611"/>
            <a:ext cx="6559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sz="1400" b="1" dirty="0"/>
              <a:t>15kDa</a:t>
            </a:r>
            <a:endParaRPr kumimoji="1" lang="zh-TW" altLang="en-US" sz="1400" b="1" dirty="0"/>
          </a:p>
        </p:txBody>
      </p:sp>
      <p:sp>
        <p:nvSpPr>
          <p:cNvPr id="18" name="文字方塊 17">
            <a:extLst>
              <a:ext uri="{FF2B5EF4-FFF2-40B4-BE49-F238E27FC236}">
                <a16:creationId xmlns:a16="http://schemas.microsoft.com/office/drawing/2014/main" id="{ABEA8C8B-7AF1-8345-AA56-D9CB966A9CA3}"/>
              </a:ext>
            </a:extLst>
          </p:cNvPr>
          <p:cNvSpPr txBox="1"/>
          <p:nvPr/>
        </p:nvSpPr>
        <p:spPr>
          <a:xfrm>
            <a:off x="8420033" y="3755317"/>
            <a:ext cx="15798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TW" dirty="0"/>
              <a:t>1  2  3  4  5  6</a:t>
            </a:r>
            <a:endParaRPr kumimoji="1" lang="zh-TW" altLang="en-US" dirty="0"/>
          </a:p>
        </p:txBody>
      </p:sp>
      <p:sp>
        <p:nvSpPr>
          <p:cNvPr id="19" name="文字方塊 18">
            <a:extLst>
              <a:ext uri="{FF2B5EF4-FFF2-40B4-BE49-F238E27FC236}">
                <a16:creationId xmlns:a16="http://schemas.microsoft.com/office/drawing/2014/main" id="{160637B1-BEF0-404A-A431-31607DF47CBC}"/>
              </a:ext>
            </a:extLst>
          </p:cNvPr>
          <p:cNvSpPr txBox="1"/>
          <p:nvPr/>
        </p:nvSpPr>
        <p:spPr>
          <a:xfrm>
            <a:off x="4356358" y="2356691"/>
            <a:ext cx="8560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b="1" dirty="0">
                <a:solidFill>
                  <a:schemeClr val="bg1"/>
                </a:solidFill>
              </a:rPr>
              <a:t>SPTLC1</a:t>
            </a:r>
            <a:endParaRPr kumimoji="1" lang="zh-TW" altLang="en-US" b="1" dirty="0">
              <a:solidFill>
                <a:schemeClr val="bg1"/>
              </a:solidFill>
            </a:endParaRPr>
          </a:p>
        </p:txBody>
      </p:sp>
      <p:sp>
        <p:nvSpPr>
          <p:cNvPr id="20" name="文字方塊 19">
            <a:extLst>
              <a:ext uri="{FF2B5EF4-FFF2-40B4-BE49-F238E27FC236}">
                <a16:creationId xmlns:a16="http://schemas.microsoft.com/office/drawing/2014/main" id="{252CD27F-4E09-8D4F-9849-86785F350FE7}"/>
              </a:ext>
            </a:extLst>
          </p:cNvPr>
          <p:cNvSpPr txBox="1"/>
          <p:nvPr/>
        </p:nvSpPr>
        <p:spPr>
          <a:xfrm>
            <a:off x="10053088" y="2899952"/>
            <a:ext cx="8483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TW" b="1" dirty="0">
                <a:latin typeface="Symbol" pitchFamily="2" charset="2"/>
              </a:rPr>
              <a:t>b</a:t>
            </a:r>
            <a:r>
              <a:rPr kumimoji="1" lang="en-US" altLang="zh-TW" b="1" dirty="0"/>
              <a:t>-actin</a:t>
            </a:r>
            <a:endParaRPr kumimoji="1" lang="zh-TW" altLang="en-US" b="1" dirty="0"/>
          </a:p>
        </p:txBody>
      </p:sp>
      <p:cxnSp>
        <p:nvCxnSpPr>
          <p:cNvPr id="3" name="直線箭頭接點 2">
            <a:extLst>
              <a:ext uri="{FF2B5EF4-FFF2-40B4-BE49-F238E27FC236}">
                <a16:creationId xmlns:a16="http://schemas.microsoft.com/office/drawing/2014/main" id="{8EFC1201-3323-6645-9918-E19AFF60F566}"/>
              </a:ext>
            </a:extLst>
          </p:cNvPr>
          <p:cNvCxnSpPr>
            <a:cxnSpLocks/>
          </p:cNvCxnSpPr>
          <p:nvPr/>
        </p:nvCxnSpPr>
        <p:spPr>
          <a:xfrm flipH="1" flipV="1">
            <a:off x="9848193" y="3101530"/>
            <a:ext cx="20489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線箭頭接點 25">
            <a:extLst>
              <a:ext uri="{FF2B5EF4-FFF2-40B4-BE49-F238E27FC236}">
                <a16:creationId xmlns:a16="http://schemas.microsoft.com/office/drawing/2014/main" id="{5D616905-E9E3-4F45-82AF-39B6597AE94D}"/>
              </a:ext>
            </a:extLst>
          </p:cNvPr>
          <p:cNvCxnSpPr>
            <a:cxnSpLocks/>
          </p:cNvCxnSpPr>
          <p:nvPr/>
        </p:nvCxnSpPr>
        <p:spPr>
          <a:xfrm flipH="1" flipV="1">
            <a:off x="4143489" y="2541357"/>
            <a:ext cx="20489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860860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41</Words>
  <Application>Microsoft Macintosh PowerPoint</Application>
  <PresentationFormat>寬螢幕</PresentationFormat>
  <Paragraphs>14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佈景主題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Yu Ting Kuo</dc:creator>
  <cp:lastModifiedBy>Yu Ting Kuo</cp:lastModifiedBy>
  <cp:revision>2</cp:revision>
  <dcterms:created xsi:type="dcterms:W3CDTF">2022-04-07T15:07:22Z</dcterms:created>
  <dcterms:modified xsi:type="dcterms:W3CDTF">2022-04-07T15:40:29Z</dcterms:modified>
</cp:coreProperties>
</file>